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59" d="100"/>
          <a:sy n="59" d="100"/>
        </p:scale>
        <p:origin x="940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1D6A1-91A0-469B-876D-3BC4C7F2DA6D}" type="datetimeFigureOut">
              <a:rPr lang="en-US" smtClean="0"/>
              <a:t>2/13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9E1AA2-E69C-490E-AF1A-880D4232BC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02149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1D6A1-91A0-469B-876D-3BC4C7F2DA6D}" type="datetimeFigureOut">
              <a:rPr lang="en-US" smtClean="0"/>
              <a:t>2/13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9E1AA2-E69C-490E-AF1A-880D4232BC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59906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1D6A1-91A0-469B-876D-3BC4C7F2DA6D}" type="datetimeFigureOut">
              <a:rPr lang="en-US" smtClean="0"/>
              <a:t>2/13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9E1AA2-E69C-490E-AF1A-880D4232BC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79395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1D6A1-91A0-469B-876D-3BC4C7F2DA6D}" type="datetimeFigureOut">
              <a:rPr lang="en-US" smtClean="0"/>
              <a:t>2/13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9E1AA2-E69C-490E-AF1A-880D4232BC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22999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1D6A1-91A0-469B-876D-3BC4C7F2DA6D}" type="datetimeFigureOut">
              <a:rPr lang="en-US" smtClean="0"/>
              <a:t>2/13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9E1AA2-E69C-490E-AF1A-880D4232BC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97746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1D6A1-91A0-469B-876D-3BC4C7F2DA6D}" type="datetimeFigureOut">
              <a:rPr lang="en-US" smtClean="0"/>
              <a:t>2/13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9E1AA2-E69C-490E-AF1A-880D4232BC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93647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1D6A1-91A0-469B-876D-3BC4C7F2DA6D}" type="datetimeFigureOut">
              <a:rPr lang="en-US" smtClean="0"/>
              <a:t>2/13/20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9E1AA2-E69C-490E-AF1A-880D4232BC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78147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1D6A1-91A0-469B-876D-3BC4C7F2DA6D}" type="datetimeFigureOut">
              <a:rPr lang="en-US" smtClean="0"/>
              <a:t>2/13/20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9E1AA2-E69C-490E-AF1A-880D4232BC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52707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1D6A1-91A0-469B-876D-3BC4C7F2DA6D}" type="datetimeFigureOut">
              <a:rPr lang="en-US" smtClean="0"/>
              <a:t>2/13/20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9E1AA2-E69C-490E-AF1A-880D4232BC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45443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1D6A1-91A0-469B-876D-3BC4C7F2DA6D}" type="datetimeFigureOut">
              <a:rPr lang="en-US" smtClean="0"/>
              <a:t>2/13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9E1AA2-E69C-490E-AF1A-880D4232BC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26001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1D6A1-91A0-469B-876D-3BC4C7F2DA6D}" type="datetimeFigureOut">
              <a:rPr lang="en-US" smtClean="0"/>
              <a:t>2/13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9E1AA2-E69C-490E-AF1A-880D4232BC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32014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81D6A1-91A0-469B-876D-3BC4C7F2DA6D}" type="datetimeFigureOut">
              <a:rPr lang="en-US" smtClean="0"/>
              <a:t>2/13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9E1AA2-E69C-490E-AF1A-880D4232BC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84298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3565071" y="4691744"/>
            <a:ext cx="6096000" cy="1200329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/>
            <a:r>
              <a:rPr lang="en-US" b="0" i="0" dirty="0" smtClean="0">
                <a:solidFill>
                  <a:srgbClr val="111111"/>
                </a:solidFill>
                <a:effectLst/>
                <a:latin typeface="Roboto"/>
              </a:rPr>
              <a:t>Amplification curves with multiple peaks indicates that multiple PCR products for our multiple target genes and house keeping genes were generated in the different groups in intestine tissue. </a:t>
            </a:r>
            <a:endParaRPr lang="en-US" b="0" i="0" dirty="0">
              <a:solidFill>
                <a:srgbClr val="111111"/>
              </a:solidFill>
              <a:effectLst/>
              <a:latin typeface="Roboto"/>
            </a:endParaRPr>
          </a:p>
        </p:txBody>
      </p:sp>
      <p:grpSp>
        <p:nvGrpSpPr>
          <p:cNvPr id="5" name="Group 4"/>
          <p:cNvGrpSpPr/>
          <p:nvPr/>
        </p:nvGrpSpPr>
        <p:grpSpPr>
          <a:xfrm>
            <a:off x="3837895" y="943651"/>
            <a:ext cx="4733925" cy="3748093"/>
            <a:chOff x="3413352" y="954536"/>
            <a:chExt cx="4733925" cy="3748093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3274"/>
            <a:stretch/>
          </p:blipFill>
          <p:spPr>
            <a:xfrm>
              <a:off x="3413352" y="1164771"/>
              <a:ext cx="4733925" cy="3537858"/>
            </a:xfrm>
            <a:prstGeom prst="rect">
              <a:avLst/>
            </a:prstGeom>
          </p:spPr>
        </p:pic>
        <p:sp>
          <p:nvSpPr>
            <p:cNvPr id="4" name="TextBox 3"/>
            <p:cNvSpPr txBox="1"/>
            <p:nvPr/>
          </p:nvSpPr>
          <p:spPr>
            <a:xfrm>
              <a:off x="5431972" y="954536"/>
              <a:ext cx="1513113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 smtClean="0"/>
                <a:t>HO-1, ZO-1 and GAPDH</a:t>
              </a:r>
              <a:endParaRPr lang="en-US" sz="1050" dirty="0"/>
            </a:p>
          </p:txBody>
        </p:sp>
      </p:grpSp>
    </p:spTree>
    <p:extLst>
      <p:ext uri="{BB962C8B-B14F-4D97-AF65-F5344CB8AC3E}">
        <p14:creationId xmlns:p14="http://schemas.microsoft.com/office/powerpoint/2010/main" val="14655103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34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Roboto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ccess</dc:creator>
  <cp:lastModifiedBy>Access</cp:lastModifiedBy>
  <cp:revision>2</cp:revision>
  <dcterms:created xsi:type="dcterms:W3CDTF">2026-02-13T20:38:45Z</dcterms:created>
  <dcterms:modified xsi:type="dcterms:W3CDTF">2026-02-14T06:40:13Z</dcterms:modified>
</cp:coreProperties>
</file>